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32040513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oel Joseph" initials="NJ" lastIdx="1" clrIdx="0">
    <p:extLst>
      <p:ext uri="{19B8F6BF-5375-455C-9EA6-DF929625EA0E}">
        <p15:presenceInfo xmlns:p15="http://schemas.microsoft.com/office/powerpoint/2012/main" userId="S::njoseph@kemri-wellcome.org::6028628b-407e-4904-a29f-3a8ff9e597e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27" d="100"/>
          <a:sy n="27" d="100"/>
        </p:scale>
        <p:origin x="34" y="2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05064" y="1770322"/>
            <a:ext cx="24030385" cy="3765997"/>
          </a:xfrm>
        </p:spPr>
        <p:txBody>
          <a:bodyPr anchor="b"/>
          <a:lstStyle>
            <a:lvl1pPr algn="ctr">
              <a:defRPr sz="94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05064" y="5681548"/>
            <a:ext cx="24030385" cy="2611658"/>
          </a:xfrm>
        </p:spPr>
        <p:txBody>
          <a:bodyPr/>
          <a:lstStyle>
            <a:lvl1pPr marL="0" indent="0" algn="ctr">
              <a:buNone/>
              <a:defRPr sz="3786"/>
            </a:lvl1pPr>
            <a:lvl2pPr marL="721142" indent="0" algn="ctr">
              <a:buNone/>
              <a:defRPr sz="3155"/>
            </a:lvl2pPr>
            <a:lvl3pPr marL="1442283" indent="0" algn="ctr">
              <a:buNone/>
              <a:defRPr sz="2839"/>
            </a:lvl3pPr>
            <a:lvl4pPr marL="2163425" indent="0" algn="ctr">
              <a:buNone/>
              <a:defRPr sz="2524"/>
            </a:lvl4pPr>
            <a:lvl5pPr marL="2884566" indent="0" algn="ctr">
              <a:buNone/>
              <a:defRPr sz="2524"/>
            </a:lvl5pPr>
            <a:lvl6pPr marL="3605708" indent="0" algn="ctr">
              <a:buNone/>
              <a:defRPr sz="2524"/>
            </a:lvl6pPr>
            <a:lvl7pPr marL="4326849" indent="0" algn="ctr">
              <a:buNone/>
              <a:defRPr sz="2524"/>
            </a:lvl7pPr>
            <a:lvl8pPr marL="5047991" indent="0" algn="ctr">
              <a:buNone/>
              <a:defRPr sz="2524"/>
            </a:lvl8pPr>
            <a:lvl9pPr marL="5769132" indent="0" algn="ctr">
              <a:buNone/>
              <a:defRPr sz="252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790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804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928992" y="575917"/>
            <a:ext cx="6908736" cy="91670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02785" y="575917"/>
            <a:ext cx="20325700" cy="91670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768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1842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6098" y="2696796"/>
            <a:ext cx="27634942" cy="4499664"/>
          </a:xfrm>
        </p:spPr>
        <p:txBody>
          <a:bodyPr anchor="b"/>
          <a:lstStyle>
            <a:lvl1pPr>
              <a:defRPr sz="94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86098" y="7239031"/>
            <a:ext cx="27634942" cy="2366267"/>
          </a:xfrm>
        </p:spPr>
        <p:txBody>
          <a:bodyPr/>
          <a:lstStyle>
            <a:lvl1pPr marL="0" indent="0">
              <a:buNone/>
              <a:defRPr sz="3786">
                <a:solidFill>
                  <a:schemeClr val="tx1">
                    <a:tint val="75000"/>
                  </a:schemeClr>
                </a:solidFill>
              </a:defRPr>
            </a:lvl1pPr>
            <a:lvl2pPr marL="721142" indent="0">
              <a:buNone/>
              <a:defRPr sz="3155">
                <a:solidFill>
                  <a:schemeClr val="tx1">
                    <a:tint val="75000"/>
                  </a:schemeClr>
                </a:solidFill>
              </a:defRPr>
            </a:lvl2pPr>
            <a:lvl3pPr marL="1442283" indent="0">
              <a:buNone/>
              <a:defRPr sz="2839">
                <a:solidFill>
                  <a:schemeClr val="tx1">
                    <a:tint val="75000"/>
                  </a:schemeClr>
                </a:solidFill>
              </a:defRPr>
            </a:lvl3pPr>
            <a:lvl4pPr marL="2163425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4pPr>
            <a:lvl5pPr marL="2884566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5pPr>
            <a:lvl6pPr marL="3605708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6pPr>
            <a:lvl7pPr marL="4326849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7pPr>
            <a:lvl8pPr marL="5047991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8pPr>
            <a:lvl9pPr marL="5769132" indent="0">
              <a:buNone/>
              <a:defRPr sz="25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449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02786" y="2879585"/>
            <a:ext cx="13617218" cy="68634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220510" y="2879585"/>
            <a:ext cx="13617218" cy="68634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430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6959" y="575918"/>
            <a:ext cx="27634942" cy="209083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6960" y="2651725"/>
            <a:ext cx="13554638" cy="1299569"/>
          </a:xfrm>
        </p:spPr>
        <p:txBody>
          <a:bodyPr anchor="b"/>
          <a:lstStyle>
            <a:lvl1pPr marL="0" indent="0">
              <a:buNone/>
              <a:defRPr sz="3786" b="1"/>
            </a:lvl1pPr>
            <a:lvl2pPr marL="721142" indent="0">
              <a:buNone/>
              <a:defRPr sz="3155" b="1"/>
            </a:lvl2pPr>
            <a:lvl3pPr marL="1442283" indent="0">
              <a:buNone/>
              <a:defRPr sz="2839" b="1"/>
            </a:lvl3pPr>
            <a:lvl4pPr marL="2163425" indent="0">
              <a:buNone/>
              <a:defRPr sz="2524" b="1"/>
            </a:lvl4pPr>
            <a:lvl5pPr marL="2884566" indent="0">
              <a:buNone/>
              <a:defRPr sz="2524" b="1"/>
            </a:lvl5pPr>
            <a:lvl6pPr marL="3605708" indent="0">
              <a:buNone/>
              <a:defRPr sz="2524" b="1"/>
            </a:lvl6pPr>
            <a:lvl7pPr marL="4326849" indent="0">
              <a:buNone/>
              <a:defRPr sz="2524" b="1"/>
            </a:lvl7pPr>
            <a:lvl8pPr marL="5047991" indent="0">
              <a:buNone/>
              <a:defRPr sz="2524" b="1"/>
            </a:lvl8pPr>
            <a:lvl9pPr marL="5769132" indent="0">
              <a:buNone/>
              <a:defRPr sz="252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6960" y="3951294"/>
            <a:ext cx="13554638" cy="58117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220511" y="2651725"/>
            <a:ext cx="13621391" cy="1299569"/>
          </a:xfrm>
        </p:spPr>
        <p:txBody>
          <a:bodyPr anchor="b"/>
          <a:lstStyle>
            <a:lvl1pPr marL="0" indent="0">
              <a:buNone/>
              <a:defRPr sz="3786" b="1"/>
            </a:lvl1pPr>
            <a:lvl2pPr marL="721142" indent="0">
              <a:buNone/>
              <a:defRPr sz="3155" b="1"/>
            </a:lvl2pPr>
            <a:lvl3pPr marL="1442283" indent="0">
              <a:buNone/>
              <a:defRPr sz="2839" b="1"/>
            </a:lvl3pPr>
            <a:lvl4pPr marL="2163425" indent="0">
              <a:buNone/>
              <a:defRPr sz="2524" b="1"/>
            </a:lvl4pPr>
            <a:lvl5pPr marL="2884566" indent="0">
              <a:buNone/>
              <a:defRPr sz="2524" b="1"/>
            </a:lvl5pPr>
            <a:lvl6pPr marL="3605708" indent="0">
              <a:buNone/>
              <a:defRPr sz="2524" b="1"/>
            </a:lvl6pPr>
            <a:lvl7pPr marL="4326849" indent="0">
              <a:buNone/>
              <a:defRPr sz="2524" b="1"/>
            </a:lvl7pPr>
            <a:lvl8pPr marL="5047991" indent="0">
              <a:buNone/>
              <a:defRPr sz="2524" b="1"/>
            </a:lvl8pPr>
            <a:lvl9pPr marL="5769132" indent="0">
              <a:buNone/>
              <a:defRPr sz="252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220511" y="3951294"/>
            <a:ext cx="13621391" cy="58117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56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09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9991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6961" y="721150"/>
            <a:ext cx="10333899" cy="2524019"/>
          </a:xfrm>
        </p:spPr>
        <p:txBody>
          <a:bodyPr anchor="b"/>
          <a:lstStyle>
            <a:lvl1pPr>
              <a:defRPr sz="50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621391" y="1557483"/>
            <a:ext cx="16220510" cy="7687241"/>
          </a:xfrm>
        </p:spPr>
        <p:txBody>
          <a:bodyPr/>
          <a:lstStyle>
            <a:lvl1pPr>
              <a:defRPr sz="5047"/>
            </a:lvl1pPr>
            <a:lvl2pPr>
              <a:defRPr sz="4416"/>
            </a:lvl2pPr>
            <a:lvl3pPr>
              <a:defRPr sz="3786"/>
            </a:lvl3pPr>
            <a:lvl4pPr>
              <a:defRPr sz="3155"/>
            </a:lvl4pPr>
            <a:lvl5pPr>
              <a:defRPr sz="3155"/>
            </a:lvl5pPr>
            <a:lvl6pPr>
              <a:defRPr sz="3155"/>
            </a:lvl6pPr>
            <a:lvl7pPr>
              <a:defRPr sz="3155"/>
            </a:lvl7pPr>
            <a:lvl8pPr>
              <a:defRPr sz="3155"/>
            </a:lvl8pPr>
            <a:lvl9pPr>
              <a:defRPr sz="315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06961" y="3245168"/>
            <a:ext cx="10333899" cy="6012074"/>
          </a:xfrm>
        </p:spPr>
        <p:txBody>
          <a:bodyPr/>
          <a:lstStyle>
            <a:lvl1pPr marL="0" indent="0">
              <a:buNone/>
              <a:defRPr sz="2524"/>
            </a:lvl1pPr>
            <a:lvl2pPr marL="721142" indent="0">
              <a:buNone/>
              <a:defRPr sz="2208"/>
            </a:lvl2pPr>
            <a:lvl3pPr marL="1442283" indent="0">
              <a:buNone/>
              <a:defRPr sz="1893"/>
            </a:lvl3pPr>
            <a:lvl4pPr marL="2163425" indent="0">
              <a:buNone/>
              <a:defRPr sz="1577"/>
            </a:lvl4pPr>
            <a:lvl5pPr marL="2884566" indent="0">
              <a:buNone/>
              <a:defRPr sz="1577"/>
            </a:lvl5pPr>
            <a:lvl6pPr marL="3605708" indent="0">
              <a:buNone/>
              <a:defRPr sz="1577"/>
            </a:lvl6pPr>
            <a:lvl7pPr marL="4326849" indent="0">
              <a:buNone/>
              <a:defRPr sz="1577"/>
            </a:lvl7pPr>
            <a:lvl8pPr marL="5047991" indent="0">
              <a:buNone/>
              <a:defRPr sz="1577"/>
            </a:lvl8pPr>
            <a:lvl9pPr marL="576913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60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6961" y="721150"/>
            <a:ext cx="10333899" cy="2524019"/>
          </a:xfrm>
        </p:spPr>
        <p:txBody>
          <a:bodyPr anchor="b"/>
          <a:lstStyle>
            <a:lvl1pPr>
              <a:defRPr sz="50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621391" y="1557483"/>
            <a:ext cx="16220510" cy="7687241"/>
          </a:xfrm>
        </p:spPr>
        <p:txBody>
          <a:bodyPr anchor="t"/>
          <a:lstStyle>
            <a:lvl1pPr marL="0" indent="0">
              <a:buNone/>
              <a:defRPr sz="5047"/>
            </a:lvl1pPr>
            <a:lvl2pPr marL="721142" indent="0">
              <a:buNone/>
              <a:defRPr sz="4416"/>
            </a:lvl2pPr>
            <a:lvl3pPr marL="1442283" indent="0">
              <a:buNone/>
              <a:defRPr sz="3786"/>
            </a:lvl3pPr>
            <a:lvl4pPr marL="2163425" indent="0">
              <a:buNone/>
              <a:defRPr sz="3155"/>
            </a:lvl4pPr>
            <a:lvl5pPr marL="2884566" indent="0">
              <a:buNone/>
              <a:defRPr sz="3155"/>
            </a:lvl5pPr>
            <a:lvl6pPr marL="3605708" indent="0">
              <a:buNone/>
              <a:defRPr sz="3155"/>
            </a:lvl6pPr>
            <a:lvl7pPr marL="4326849" indent="0">
              <a:buNone/>
              <a:defRPr sz="3155"/>
            </a:lvl7pPr>
            <a:lvl8pPr marL="5047991" indent="0">
              <a:buNone/>
              <a:defRPr sz="3155"/>
            </a:lvl8pPr>
            <a:lvl9pPr marL="5769132" indent="0">
              <a:buNone/>
              <a:defRPr sz="315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06961" y="3245168"/>
            <a:ext cx="10333899" cy="6012074"/>
          </a:xfrm>
        </p:spPr>
        <p:txBody>
          <a:bodyPr/>
          <a:lstStyle>
            <a:lvl1pPr marL="0" indent="0">
              <a:buNone/>
              <a:defRPr sz="2524"/>
            </a:lvl1pPr>
            <a:lvl2pPr marL="721142" indent="0">
              <a:buNone/>
              <a:defRPr sz="2208"/>
            </a:lvl2pPr>
            <a:lvl3pPr marL="1442283" indent="0">
              <a:buNone/>
              <a:defRPr sz="1893"/>
            </a:lvl3pPr>
            <a:lvl4pPr marL="2163425" indent="0">
              <a:buNone/>
              <a:defRPr sz="1577"/>
            </a:lvl4pPr>
            <a:lvl5pPr marL="2884566" indent="0">
              <a:buNone/>
              <a:defRPr sz="1577"/>
            </a:lvl5pPr>
            <a:lvl6pPr marL="3605708" indent="0">
              <a:buNone/>
              <a:defRPr sz="1577"/>
            </a:lvl6pPr>
            <a:lvl7pPr marL="4326849" indent="0">
              <a:buNone/>
              <a:defRPr sz="1577"/>
            </a:lvl7pPr>
            <a:lvl8pPr marL="5047991" indent="0">
              <a:buNone/>
              <a:defRPr sz="1577"/>
            </a:lvl8pPr>
            <a:lvl9pPr marL="576913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098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02787" y="575918"/>
            <a:ext cx="27634942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2787" y="2879585"/>
            <a:ext cx="27634942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02785" y="10025968"/>
            <a:ext cx="7209115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D5165-24C5-4EE1-935E-ACE6200ED48D}" type="datetimeFigureOut">
              <a:rPr lang="en-GB" smtClean="0"/>
              <a:t>06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613420" y="10025968"/>
            <a:ext cx="10813673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628614" y="10025968"/>
            <a:ext cx="7209115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90AE2-CBB3-40D4-94C9-EC532B6E20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897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442283" rtl="0" eaLnBrk="1" latinLnBrk="0" hangingPunct="1">
        <a:lnSpc>
          <a:spcPct val="90000"/>
        </a:lnSpc>
        <a:spcBef>
          <a:spcPct val="0"/>
        </a:spcBef>
        <a:buNone/>
        <a:defRPr sz="6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571" indent="-360571" algn="l" defTabSz="1442283" rtl="0" eaLnBrk="1" latinLnBrk="0" hangingPunct="1">
        <a:lnSpc>
          <a:spcPct val="90000"/>
        </a:lnSpc>
        <a:spcBef>
          <a:spcPts val="1577"/>
        </a:spcBef>
        <a:buFont typeface="Arial" panose="020B0604020202020204" pitchFamily="34" charset="0"/>
        <a:buChar char="•"/>
        <a:defRPr sz="4416" kern="1200">
          <a:solidFill>
            <a:schemeClr val="tx1"/>
          </a:solidFill>
          <a:latin typeface="+mn-lt"/>
          <a:ea typeface="+mn-ea"/>
          <a:cs typeface="+mn-cs"/>
        </a:defRPr>
      </a:lvl1pPr>
      <a:lvl2pPr marL="1081712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3786" kern="1200">
          <a:solidFill>
            <a:schemeClr val="tx1"/>
          </a:solidFill>
          <a:latin typeface="+mn-lt"/>
          <a:ea typeface="+mn-ea"/>
          <a:cs typeface="+mn-cs"/>
        </a:defRPr>
      </a:lvl2pPr>
      <a:lvl3pPr marL="1802854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3155" kern="1200">
          <a:solidFill>
            <a:schemeClr val="tx1"/>
          </a:solidFill>
          <a:latin typeface="+mn-lt"/>
          <a:ea typeface="+mn-ea"/>
          <a:cs typeface="+mn-cs"/>
        </a:defRPr>
      </a:lvl3pPr>
      <a:lvl4pPr marL="2523995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4pPr>
      <a:lvl5pPr marL="3245137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5pPr>
      <a:lvl6pPr marL="3966279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6pPr>
      <a:lvl7pPr marL="4687420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7pPr>
      <a:lvl8pPr marL="5408562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8pPr>
      <a:lvl9pPr marL="6129703" indent="-360571" algn="l" defTabSz="1442283" rtl="0" eaLnBrk="1" latinLnBrk="0" hangingPunct="1">
        <a:lnSpc>
          <a:spcPct val="90000"/>
        </a:lnSpc>
        <a:spcBef>
          <a:spcPts val="789"/>
        </a:spcBef>
        <a:buFont typeface="Arial" panose="020B0604020202020204" pitchFamily="34" charset="0"/>
        <a:buChar char="•"/>
        <a:defRPr sz="28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1pPr>
      <a:lvl2pPr marL="721142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2pPr>
      <a:lvl3pPr marL="1442283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3pPr>
      <a:lvl4pPr marL="2163425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4pPr>
      <a:lvl5pPr marL="2884566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5pPr>
      <a:lvl6pPr marL="3605708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6pPr>
      <a:lvl7pPr marL="4326849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7pPr>
      <a:lvl8pPr marL="5047991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8pPr>
      <a:lvl9pPr marL="5769132" algn="l" defTabSz="1442283" rtl="0" eaLnBrk="1" latinLnBrk="0" hangingPunct="1">
        <a:defRPr sz="28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75B11E5-C5F6-416C-B90C-DA8E1659E03B}"/>
              </a:ext>
            </a:extLst>
          </p:cNvPr>
          <p:cNvSpPr txBox="1"/>
          <p:nvPr/>
        </p:nvSpPr>
        <p:spPr>
          <a:xfrm>
            <a:off x="10578582" y="68881"/>
            <a:ext cx="5586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four antenatal visits</a:t>
            </a:r>
          </a:p>
        </p:txBody>
      </p:sp>
      <p:pic>
        <p:nvPicPr>
          <p:cNvPr id="6" name="Picture 5" descr="A picture containing table&#10;&#10;Description automatically generated">
            <a:extLst>
              <a:ext uri="{FF2B5EF4-FFF2-40B4-BE49-F238E27FC236}">
                <a16:creationId xmlns:a16="http://schemas.microsoft.com/office/drawing/2014/main" id="{DF862BD0-8C35-4F04-861B-9580E552B1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58588" y="1206018"/>
            <a:ext cx="6458400" cy="8639324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35ED41EA-1BF0-48E0-BFC7-F856D9A060E5}"/>
              </a:ext>
            </a:extLst>
          </p:cNvPr>
          <p:cNvGrpSpPr/>
          <p:nvPr/>
        </p:nvGrpSpPr>
        <p:grpSpPr>
          <a:xfrm>
            <a:off x="199078" y="1385744"/>
            <a:ext cx="1488880" cy="7736218"/>
            <a:chOff x="5720570" y="952909"/>
            <a:chExt cx="967168" cy="8455544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F56E52D-70A1-4218-A04B-B58EC238DF04}"/>
                </a:ext>
              </a:extLst>
            </p:cNvPr>
            <p:cNvGrpSpPr/>
            <p:nvPr/>
          </p:nvGrpSpPr>
          <p:grpSpPr>
            <a:xfrm>
              <a:off x="5873547" y="8357173"/>
              <a:ext cx="721009" cy="1051280"/>
              <a:chOff x="5873547" y="8357173"/>
              <a:chExt cx="721009" cy="1051280"/>
            </a:xfrm>
          </p:grpSpPr>
          <p:sp>
            <p:nvSpPr>
              <p:cNvPr id="24" name="Left Brace 23">
                <a:extLst>
                  <a:ext uri="{FF2B5EF4-FFF2-40B4-BE49-F238E27FC236}">
                    <a16:creationId xmlns:a16="http://schemas.microsoft.com/office/drawing/2014/main" id="{A2FA2A6F-550B-46D5-814D-543438E36F7D}"/>
                  </a:ext>
                </a:extLst>
              </p:cNvPr>
              <p:cNvSpPr/>
              <p:nvPr/>
            </p:nvSpPr>
            <p:spPr>
              <a:xfrm>
                <a:off x="6132681" y="8357173"/>
                <a:ext cx="461875" cy="105128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52C3744-716F-4671-BCC5-7BEA1AF082D5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2C261FE-FD2E-4059-A636-E5BD92DB2B47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E7AFF130-EC68-4A8D-B090-F31FD72C6C70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C0F1AD9-2196-4E23-ACC8-BEBA22D10096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A91A9AF-FFA3-435B-83B5-0B599992B7F3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A13C3376-B018-4D65-85D7-CDE88E87F69E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19A68CA-EB29-4752-A487-658EFDD808AB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9407CCC-0C7A-47C1-834E-3706F209ACAA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2647E2F0-AF63-4D9B-8A92-4DD5584B9FC8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857E9822-6CD4-4CC4-9BF3-F71063D6EE00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6C8A2E55-4DB1-4EBB-876E-E6C0023DFF9F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F3CEEB2A-C714-429E-8ECF-4E5C843CED83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9D4861A-1458-472F-8490-31B9A09CE4FC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B2E91814-0E78-4E7D-BAD5-939E118254B9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1B130485-53A1-4BC0-96AB-02EE262EFCBF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B1122C0-F0C5-4B32-9CEE-4E51E532A00A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6" name="Picture 25">
            <a:extLst>
              <a:ext uri="{FF2B5EF4-FFF2-40B4-BE49-F238E27FC236}">
                <a16:creationId xmlns:a16="http://schemas.microsoft.com/office/drawing/2014/main" id="{85E54878-718B-4938-AA5B-93BCA414B9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052627" y="1207032"/>
            <a:ext cx="6548307" cy="87516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74B2DE2-07A6-4CE2-9AE0-647905954D8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00933" y="1206018"/>
            <a:ext cx="6548307" cy="876781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9C70D87-8BC9-46B5-A78E-185C4DC41CA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91334" y="1161162"/>
            <a:ext cx="6377722" cy="85725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3CE6ABE3-3035-4BF7-AE6C-DDD0DF5B731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270692" y="2786930"/>
            <a:ext cx="1338602" cy="24094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77470D0-357D-4F41-823C-7FFA8B2F5AA0}"/>
              </a:ext>
            </a:extLst>
          </p:cNvPr>
          <p:cNvSpPr txBox="1"/>
          <p:nvPr/>
        </p:nvSpPr>
        <p:spPr>
          <a:xfrm>
            <a:off x="3372779" y="514834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911A042-2266-470B-B59F-381868A525AE}"/>
              </a:ext>
            </a:extLst>
          </p:cNvPr>
          <p:cNvSpPr txBox="1"/>
          <p:nvPr/>
        </p:nvSpPr>
        <p:spPr>
          <a:xfrm>
            <a:off x="9829602" y="44442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0AEA685-75D5-43D3-89EA-F187BCE38741}"/>
              </a:ext>
            </a:extLst>
          </p:cNvPr>
          <p:cNvSpPr txBox="1"/>
          <p:nvPr/>
        </p:nvSpPr>
        <p:spPr>
          <a:xfrm>
            <a:off x="16286422" y="514831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674CD10-CC31-46FD-9A10-24D6CD3E43E5}"/>
              </a:ext>
            </a:extLst>
          </p:cNvPr>
          <p:cNvSpPr txBox="1"/>
          <p:nvPr/>
        </p:nvSpPr>
        <p:spPr>
          <a:xfrm>
            <a:off x="22783302" y="44442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904040A-90FC-4664-9B04-A1B81D2C535C}"/>
              </a:ext>
            </a:extLst>
          </p:cNvPr>
          <p:cNvSpPr txBox="1"/>
          <p:nvPr/>
        </p:nvSpPr>
        <p:spPr>
          <a:xfrm>
            <a:off x="28871556" y="1344017"/>
            <a:ext cx="2969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9FE7901-0F4E-4C7C-89F2-455D14BA7799}"/>
              </a:ext>
            </a:extLst>
          </p:cNvPr>
          <p:cNvSpPr txBox="1"/>
          <p:nvPr/>
        </p:nvSpPr>
        <p:spPr>
          <a:xfrm>
            <a:off x="795142" y="9973830"/>
            <a:ext cx="295613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00CC"/>
                </a:solidFill>
                <a:latin typeface="Calibri Light" panose="020F0302020204030204" pitchFamily="34" charset="0"/>
                <a:ea typeface="Calibri" panose="020F0502020204030204" pitchFamily="34" charset="0"/>
              </a:rPr>
              <a:t> 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</a:rPr>
              <a:t>The heat plots show the percentage changes in U5M rates after scale-up relative to Business-as-usual. Therefore, </a:t>
            </a:r>
            <a:r>
              <a:rPr lang="en-GB" sz="1800" dirty="0">
                <a:effectLst/>
                <a:latin typeface="Calibri Light" panose="020F0302020204030204" pitchFamily="34" charset="0"/>
                <a:ea typeface="Calibri" panose="020F0502020204030204" pitchFamily="34" charset="0"/>
              </a:rPr>
              <a:t> red shade represent values greater than zero implying  that business as usual yields a greater impact on U5M compared to the alternate scale up scenario and a green shade implies that the scale up scenario yields a relative greater impact than the Business-as-usual scenario. All subsequent plots should be interpreted similarly with respect to the 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</a:rPr>
              <a:t>specific intervention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283410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1F0D217-5174-43FF-AF90-7CF25F5CC3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48796" y="1891767"/>
            <a:ext cx="6459247" cy="878053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B1F3763-B4A6-4189-A3DF-45187F292C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588533" y="1921517"/>
            <a:ext cx="6459247" cy="875078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5A875FF-0FD8-4F9E-B0F6-E8E3462E51A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070354" y="1965839"/>
            <a:ext cx="6459247" cy="8706467"/>
          </a:xfrm>
          <a:prstGeom prst="rect">
            <a:avLst/>
          </a:prstGeom>
        </p:spPr>
      </p:pic>
      <p:grpSp>
        <p:nvGrpSpPr>
          <p:cNvPr id="29" name="Group 28">
            <a:extLst>
              <a:ext uri="{FF2B5EF4-FFF2-40B4-BE49-F238E27FC236}">
                <a16:creationId xmlns:a16="http://schemas.microsoft.com/office/drawing/2014/main" id="{E9C97F39-8160-4F2C-8BD5-EF136AEA1AE3}"/>
              </a:ext>
            </a:extLst>
          </p:cNvPr>
          <p:cNvGrpSpPr/>
          <p:nvPr/>
        </p:nvGrpSpPr>
        <p:grpSpPr>
          <a:xfrm>
            <a:off x="1620044" y="2117243"/>
            <a:ext cx="1488880" cy="7736217"/>
            <a:chOff x="5720570" y="952909"/>
            <a:chExt cx="967168" cy="8455543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9F0696E-6C05-4EF8-A894-C68600E50E7F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46" name="Left Brace 45">
                <a:extLst>
                  <a:ext uri="{FF2B5EF4-FFF2-40B4-BE49-F238E27FC236}">
                    <a16:creationId xmlns:a16="http://schemas.microsoft.com/office/drawing/2014/main" id="{98EABDA7-B45D-4252-BC0B-16C396D96F22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D4DE3086-7F49-4E92-B59B-072410BC4C5E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FD22B1B3-0851-4203-AD90-17E451BCDB73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44" name="Left Brace 43">
                <a:extLst>
                  <a:ext uri="{FF2B5EF4-FFF2-40B4-BE49-F238E27FC236}">
                    <a16:creationId xmlns:a16="http://schemas.microsoft.com/office/drawing/2014/main" id="{3F70BA31-5BBF-4C6E-939C-53077F8857D1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EC4A39F-8718-416B-A71F-6D5A12BA1212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0758A03E-A89D-4093-B8B6-0FC89A7AD92C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42" name="Left Brace 41">
                <a:extLst>
                  <a:ext uri="{FF2B5EF4-FFF2-40B4-BE49-F238E27FC236}">
                    <a16:creationId xmlns:a16="http://schemas.microsoft.com/office/drawing/2014/main" id="{6703B23D-6601-4517-B71E-76A7072131E8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F1AF792-1F12-45C9-8871-D30C022F4EE2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2580F31-A4D8-448D-865C-85A5DCD6BD24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40" name="Left Brace 39">
                <a:extLst>
                  <a:ext uri="{FF2B5EF4-FFF2-40B4-BE49-F238E27FC236}">
                    <a16:creationId xmlns:a16="http://schemas.microsoft.com/office/drawing/2014/main" id="{D9DEC94F-2514-4178-A30D-460FA800CA19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9540B16-F911-460C-850E-BC58D0428B62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B342C3B0-AE2F-440D-9590-E60F5D2A20D6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38" name="Left Brace 37">
                <a:extLst>
                  <a:ext uri="{FF2B5EF4-FFF2-40B4-BE49-F238E27FC236}">
                    <a16:creationId xmlns:a16="http://schemas.microsoft.com/office/drawing/2014/main" id="{AEF2BE96-BD5A-4DEA-AFC9-3F7B4AAB1A0B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32A8B53-D8BD-45F8-B81C-22B2C781C634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96C988E9-DEC1-4B14-8064-904CD657240D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36" name="Left Brace 35">
                <a:extLst>
                  <a:ext uri="{FF2B5EF4-FFF2-40B4-BE49-F238E27FC236}">
                    <a16:creationId xmlns:a16="http://schemas.microsoft.com/office/drawing/2014/main" id="{F84C38FE-9306-4EE2-952F-6B00D8243F4B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892F0BA-B310-4F9F-A9AB-1E5BF1295E56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C0CA9C43-3F44-4F50-8295-80C87C938645}"/>
              </a:ext>
            </a:extLst>
          </p:cNvPr>
          <p:cNvSpPr txBox="1"/>
          <p:nvPr/>
        </p:nvSpPr>
        <p:spPr>
          <a:xfrm>
            <a:off x="4612641" y="282197"/>
            <a:ext cx="221894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06426"/>
            <a:r>
              <a:rPr lang="en-GB" sz="2000" b="1" dirty="0">
                <a:solidFill>
                  <a:prstClr val="black"/>
                </a:solidFill>
                <a:latin typeface="Calibri" panose="020F0502020204030204"/>
              </a:rPr>
              <a:t>U5M changes after scale up of child ITN use </a:t>
            </a:r>
            <a:r>
              <a:rPr lang="en-GB" sz="2000" i="1" dirty="0">
                <a:solidFill>
                  <a:prstClr val="black"/>
                </a:solidFill>
                <a:latin typeface="Calibri" panose="020F0502020204030204"/>
              </a:rPr>
              <a:t>( Counties presented in grey are classified as Malaria low risk areas according Malaria control programme and hence excluded for intervention scale up</a:t>
            </a:r>
            <a:r>
              <a:rPr lang="en-GB" sz="2000" b="1" dirty="0">
                <a:solidFill>
                  <a:prstClr val="black"/>
                </a:solidFill>
                <a:latin typeface="Calibri" panose="020F0502020204030204"/>
              </a:rPr>
              <a:t>)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6C21561B-C241-4914-B832-2E1007A9D9B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552172" y="4216417"/>
            <a:ext cx="1078992" cy="2062074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CE8CAB8-50F8-4FF6-A053-B41ECD8CB15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93360" y="1962528"/>
            <a:ext cx="6395173" cy="857250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B87D1109-D989-40C4-A40A-F948D70E1CB1}"/>
              </a:ext>
            </a:extLst>
          </p:cNvPr>
          <p:cNvSpPr txBox="1"/>
          <p:nvPr/>
        </p:nvSpPr>
        <p:spPr>
          <a:xfrm>
            <a:off x="4921761" y="115820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5EB801D-EDA6-45DC-992C-99677CE18C8D}"/>
              </a:ext>
            </a:extLst>
          </p:cNvPr>
          <p:cNvSpPr txBox="1"/>
          <p:nvPr/>
        </p:nvSpPr>
        <p:spPr>
          <a:xfrm>
            <a:off x="113785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2A4D36A-FD01-41C8-BC3E-147C4ED39592}"/>
              </a:ext>
            </a:extLst>
          </p:cNvPr>
          <p:cNvSpPr txBox="1"/>
          <p:nvPr/>
        </p:nvSpPr>
        <p:spPr>
          <a:xfrm>
            <a:off x="17835404" y="1158202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6E957C1-FEAD-4998-AE7D-393F6313827E}"/>
              </a:ext>
            </a:extLst>
          </p:cNvPr>
          <p:cNvSpPr txBox="1"/>
          <p:nvPr/>
        </p:nvSpPr>
        <p:spPr>
          <a:xfrm>
            <a:off x="243322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34865086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FEDE395-C9D6-4AE4-99D4-BF657D675BB8}"/>
              </a:ext>
            </a:extLst>
          </p:cNvPr>
          <p:cNvSpPr txBox="1"/>
          <p:nvPr/>
        </p:nvSpPr>
        <p:spPr>
          <a:xfrm>
            <a:off x="10414234" y="106749"/>
            <a:ext cx="56060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use of antimalarials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C192A44-9677-4275-A23C-47F3AA1329C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51159" y="1564579"/>
            <a:ext cx="6422508" cy="875160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A121AF56-BF85-44AF-9645-CAE3DA4EF29F}"/>
              </a:ext>
            </a:extLst>
          </p:cNvPr>
          <p:cNvGrpSpPr/>
          <p:nvPr/>
        </p:nvGrpSpPr>
        <p:grpSpPr>
          <a:xfrm>
            <a:off x="1620044" y="1800446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8B11626-A407-4DE8-A038-76593030AC42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96D711F3-C165-4DB6-ACF3-B961E999625C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2339AB2-C389-4F67-B753-8901D95C837D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0687720-2788-46E2-A8B1-6FB1952FD18B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EF5D893B-1EC8-4DAD-A019-B0015217A2B0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B5C681E-F322-40E7-8D6E-1DC90DDF4DC8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2E27A5E8-47B8-4A07-B348-3A59DB078C0B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6E647FD3-CFFF-43D1-A41F-7D0A134DF570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F2E1785-190B-4BE1-92F0-A5A072322657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FC030C6A-8D97-482B-B95B-5B4324B1F5BF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4D4A18FA-F220-43BD-950A-4D1C5726645A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B4C94E7-66DE-43E0-8952-7AC3F55015DE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DC1B77C1-59D1-4FCF-8275-8087E28E1397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0BD00575-7EB6-49A7-88E1-C403585E2208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87DD6CD-4205-45F1-B915-C973238811C4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6D94B4FE-D4C7-4E64-BB8E-39DB42EFD613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3B6E9636-CCCA-4EA1-8DA9-7E957FE328B1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CC895A1-F690-4AEC-A8B9-DFD43707710D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81DF1CDB-E6D5-4D45-B4F9-2E69CBCD2E2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34458" y="1502687"/>
            <a:ext cx="6487853" cy="87516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7291065-529F-412A-B3C0-DF3453F9FCA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822308" y="1502691"/>
            <a:ext cx="6458400" cy="868094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65A3D6C-77E1-4840-AF6A-ED752246E7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49998" y="1502686"/>
            <a:ext cx="6305743" cy="864846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B0694F6-8C02-48F1-A9A0-FF62562D3AD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691658" y="3201629"/>
            <a:ext cx="1338602" cy="240948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8AF4CFE1-5D1F-4FA7-81ED-670AA8C96F33}"/>
              </a:ext>
            </a:extLst>
          </p:cNvPr>
          <p:cNvSpPr txBox="1"/>
          <p:nvPr/>
        </p:nvSpPr>
        <p:spPr>
          <a:xfrm>
            <a:off x="4731847" y="856357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5922E8D-5ECF-45F4-A614-6DA07C4592F4}"/>
              </a:ext>
            </a:extLst>
          </p:cNvPr>
          <p:cNvSpPr txBox="1"/>
          <p:nvPr/>
        </p:nvSpPr>
        <p:spPr>
          <a:xfrm>
            <a:off x="11188670" y="785948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E174243-928C-470F-86A3-CE051BAF406C}"/>
              </a:ext>
            </a:extLst>
          </p:cNvPr>
          <p:cNvSpPr txBox="1"/>
          <p:nvPr/>
        </p:nvSpPr>
        <p:spPr>
          <a:xfrm>
            <a:off x="17645490" y="856354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EA973A7-A653-4078-BA26-4DF2FABCB7E3}"/>
              </a:ext>
            </a:extLst>
          </p:cNvPr>
          <p:cNvSpPr txBox="1"/>
          <p:nvPr/>
        </p:nvSpPr>
        <p:spPr>
          <a:xfrm>
            <a:off x="24142370" y="785948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17B4AA3-09CB-4A9D-8A8E-2CA71F9AC96B}"/>
              </a:ext>
            </a:extLst>
          </p:cNvPr>
          <p:cNvSpPr txBox="1"/>
          <p:nvPr/>
        </p:nvSpPr>
        <p:spPr>
          <a:xfrm>
            <a:off x="2825802" y="10262457"/>
            <a:ext cx="26886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Red shading  implies that business as usual yields a greater impact on U5M compared to the alternate scale up scenario and a green shade implies that the scale up scenario yields a relative greater impact than the Business-as-usual scenario</a:t>
            </a:r>
          </a:p>
        </p:txBody>
      </p:sp>
    </p:spTree>
    <p:extLst>
      <p:ext uri="{BB962C8B-B14F-4D97-AF65-F5344CB8AC3E}">
        <p14:creationId xmlns:p14="http://schemas.microsoft.com/office/powerpoint/2010/main" val="3617094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415E0D-15F1-4841-B2C8-1AB68149A562}"/>
              </a:ext>
            </a:extLst>
          </p:cNvPr>
          <p:cNvSpPr txBox="1"/>
          <p:nvPr/>
        </p:nvSpPr>
        <p:spPr>
          <a:xfrm>
            <a:off x="10995579" y="384993"/>
            <a:ext cx="66319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access to improved sanit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AB4DC4-DB78-4E4C-89CA-E69ACAB756A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83494" y="2066735"/>
            <a:ext cx="6458400" cy="8658645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00F7D5A4-8C7E-4D86-92EF-10E2BCCDF2AD}"/>
              </a:ext>
            </a:extLst>
          </p:cNvPr>
          <p:cNvGrpSpPr/>
          <p:nvPr/>
        </p:nvGrpSpPr>
        <p:grpSpPr>
          <a:xfrm>
            <a:off x="1660535" y="2226563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4308364-F2B4-4B39-90C1-E3973B32BFA8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9F145E58-29B5-4538-8D43-821C9D4600E9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1A47E64-BDD0-4E01-90F8-8DB871403381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464D990F-8005-45FE-8EA5-D9B82640D7D0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BBF55DD9-2579-4EE4-94D0-F0D4F999E7B7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6B1F53A-3355-48FB-B897-029A6D7DD0A5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E729F313-199F-4664-9F56-252972385DA4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464A172E-7BE6-4EE0-B8E5-7B89676AE818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9042152-D898-49C4-BB3F-416C1ABB6E3F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44DF0DB4-65E9-4E68-94FC-993E8C5CD5E3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E09DB3CE-ABAC-4238-AAE8-864BA0138A4C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3675EFA-274E-4EAB-80B0-3C93BFF9E197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6701B11-58C1-4A85-8442-AEB6B13A7D9B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DB9E7375-F97B-4BA4-888E-A632D2DDE69F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6EFB705-E5A3-47F4-BFE1-854E23FA5E16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EF59CB88-398B-45DA-B19C-1DF49C510191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13FAC022-AB28-406A-BE02-B1C790DB2E4F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A9B726C-B89F-4F0B-B150-8CDA648F9AAD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5C09CA54-B9EB-4133-B6D9-CCDE3374DC2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704678" y="2076701"/>
            <a:ext cx="6458400" cy="867786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7EC792B-3E81-4E12-B6A5-93728FD2866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163078" y="2066735"/>
            <a:ext cx="6458400" cy="868783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50ADE60-5EB6-4639-AEB9-09015338BFF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24696" y="2066732"/>
            <a:ext cx="6379985" cy="85725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F5451A7-BFF4-43AB-A171-03CA8C1E010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882447" y="3696361"/>
            <a:ext cx="1338602" cy="240948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DE1D94D-FC62-44EB-8B7F-E1BF06BA80D9}"/>
              </a:ext>
            </a:extLst>
          </p:cNvPr>
          <p:cNvSpPr txBox="1"/>
          <p:nvPr/>
        </p:nvSpPr>
        <p:spPr>
          <a:xfrm>
            <a:off x="4793745" y="1246330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025F7C8-5D65-47F4-9E9B-BB42F9AAAB13}"/>
              </a:ext>
            </a:extLst>
          </p:cNvPr>
          <p:cNvSpPr txBox="1"/>
          <p:nvPr/>
        </p:nvSpPr>
        <p:spPr>
          <a:xfrm>
            <a:off x="11250568" y="1175921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D3C27FA-29AB-4830-A1F0-8E947AAA07C6}"/>
              </a:ext>
            </a:extLst>
          </p:cNvPr>
          <p:cNvSpPr txBox="1"/>
          <p:nvPr/>
        </p:nvSpPr>
        <p:spPr>
          <a:xfrm>
            <a:off x="17707388" y="1246327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4CB82D3-E46B-44AB-8C97-253B7F4F44DC}"/>
              </a:ext>
            </a:extLst>
          </p:cNvPr>
          <p:cNvSpPr txBox="1"/>
          <p:nvPr/>
        </p:nvSpPr>
        <p:spPr>
          <a:xfrm>
            <a:off x="24204268" y="1175921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20739635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42445A7-F5DA-4AB2-A124-F2DE23E7B724}"/>
              </a:ext>
            </a:extLst>
          </p:cNvPr>
          <p:cNvSpPr txBox="1"/>
          <p:nvPr/>
        </p:nvSpPr>
        <p:spPr>
          <a:xfrm>
            <a:off x="10344854" y="439637"/>
            <a:ext cx="95862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initiation of breastfeeding within the first hour after birth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35DE4E4-91E4-4BF6-BC29-F72A724628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53900" y="1892661"/>
            <a:ext cx="6458400" cy="8774999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3A211594-25A8-442C-8FBF-D438E686BA74}"/>
              </a:ext>
            </a:extLst>
          </p:cNvPr>
          <p:cNvGrpSpPr/>
          <p:nvPr/>
        </p:nvGrpSpPr>
        <p:grpSpPr>
          <a:xfrm>
            <a:off x="1620044" y="2168843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B461F91-9BF1-4B75-A692-5AE3B866C4B3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5B6E92B3-34A9-4E0E-BE6F-5E69643C8F46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5D9C733-627B-435B-911C-DED0C807FFE6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A4CDF37-9DF6-4EBC-B050-EF9ABCF94E4E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512B4DE4-8710-4EF4-A301-2958C9443A17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5354CDE-5524-4C04-912C-85ED491A9188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5F7726C-7183-438C-8159-B419E8261546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077C11A2-85A3-42F3-B2DE-AFB504DFEC84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E2A719B-4BC6-44B8-83B5-0ECF8D0DD566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E38C26D7-1656-498E-9FA2-5A8C784AD2D4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D673EEFB-8302-45EF-A34B-A1F2A0232A5E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E66DFC3-6264-4E39-92FD-3B63EF3FE080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6E6F18A-B4A0-4C16-9442-6B822100C70D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6A06127D-5F4B-42B4-8B42-A152CAC3D1E7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F448A63-4AD6-4CE2-AAAC-9C11A9860A14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1559907-EA26-4F51-AB8F-B7AB534FCBC2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C1B4509D-8A1C-43A0-8BC9-065591EB5788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BEDE719-97C0-4B89-93F8-FBB7A884115A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B05AE070-9B19-4356-AF62-B0655070F6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020256" y="1844319"/>
            <a:ext cx="6458400" cy="871280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1CEF513E-5879-40A8-BCF2-9A568ECCCD7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604530" y="1844319"/>
            <a:ext cx="6458400" cy="872382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72274293-FDF2-49FA-AA97-1808E3881A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88166" y="1758659"/>
            <a:ext cx="6456224" cy="880948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F3F90F6C-34C2-4C75-86A0-5542D7449D0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19471" y="3533123"/>
            <a:ext cx="1338602" cy="240948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5146A054-707A-483F-A3DF-E3291889170C}"/>
              </a:ext>
            </a:extLst>
          </p:cNvPr>
          <p:cNvSpPr txBox="1"/>
          <p:nvPr/>
        </p:nvSpPr>
        <p:spPr>
          <a:xfrm>
            <a:off x="4793745" y="1246330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B57773F-69D7-46B2-BC26-F2B7B14F1459}"/>
              </a:ext>
            </a:extLst>
          </p:cNvPr>
          <p:cNvSpPr txBox="1"/>
          <p:nvPr/>
        </p:nvSpPr>
        <p:spPr>
          <a:xfrm>
            <a:off x="11250568" y="1175921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2A57F5-26CC-43A6-9BF9-17EC9495EA33}"/>
              </a:ext>
            </a:extLst>
          </p:cNvPr>
          <p:cNvSpPr txBox="1"/>
          <p:nvPr/>
        </p:nvSpPr>
        <p:spPr>
          <a:xfrm>
            <a:off x="17707388" y="1246327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E5B89D1-5813-4C04-A80F-F86BB3887E2D}"/>
              </a:ext>
            </a:extLst>
          </p:cNvPr>
          <p:cNvSpPr txBox="1"/>
          <p:nvPr/>
        </p:nvSpPr>
        <p:spPr>
          <a:xfrm>
            <a:off x="24204268" y="1175921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16378471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F39E51B-2440-49D8-A6FB-1621C08533F4}"/>
              </a:ext>
            </a:extLst>
          </p:cNvPr>
          <p:cNvSpPr txBox="1"/>
          <p:nvPr/>
        </p:nvSpPr>
        <p:spPr>
          <a:xfrm>
            <a:off x="9574509" y="243624"/>
            <a:ext cx="67730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recommended fever treatmen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E9F6FA7-8E04-40C0-8E48-799B7D75D1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16109" y="1780730"/>
            <a:ext cx="6458400" cy="868094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16DE802A-36F9-4482-9402-B0775F0D12BE}"/>
              </a:ext>
            </a:extLst>
          </p:cNvPr>
          <p:cNvGrpSpPr/>
          <p:nvPr/>
        </p:nvGrpSpPr>
        <p:grpSpPr>
          <a:xfrm>
            <a:off x="2067821" y="2023602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3D62773-B5FA-44FB-A4AA-BEC8ABD6906C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B67E1FF8-EACA-4C3F-8973-B28B9D713817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4F8FA3E-17E7-41BA-804F-42ADC954434C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81A9AD8A-25DC-441B-8199-3FCC978F21F2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34DC39A2-3644-486E-A968-5697BB7FD98A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C70DD3E-2501-4B86-B29A-BEBEC4912CDE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C08708F0-3BEA-4E4C-9F93-A5CF967FAAD6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706757AF-98AA-423D-8C81-633268DB9353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B693799-7B31-422A-A919-5C622F08ABA9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6CF9E651-3C8D-4780-912A-E08C2478576D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7409CF48-6C73-443B-9911-D151653BADAF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68884BE-BC26-425A-8B4D-76FC4282D51D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7850804-BA3D-4975-9635-4D10E79FB84D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9BD52951-9538-4A69-9F7C-9F0C2C1BA9DF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F64B599-4813-45E5-8AB8-8B0C4EF69433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E9CF0586-A13D-4201-8B55-FEFA92EA120C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551B22B7-FD62-464A-B03B-CD583AB00ABE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080E768-3891-4011-AABA-C51375B41713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16F3C715-790F-463E-9E01-17243CA407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080879" y="1782417"/>
            <a:ext cx="6504930" cy="872442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32C2A39-0A74-4221-825F-3ACF245A7B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646432" y="1780730"/>
            <a:ext cx="6385124" cy="85725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AA3A8F6-3CBE-4963-8D29-97E383FA9F2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635132" y="1780730"/>
            <a:ext cx="6385124" cy="85725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E2F5937-8EF6-4848-9F31-44B8E171DE7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30272" y="3493400"/>
            <a:ext cx="1338602" cy="240948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39EBA82-B5BC-41EF-A43A-8B0BAE10226C}"/>
              </a:ext>
            </a:extLst>
          </p:cNvPr>
          <p:cNvSpPr txBox="1"/>
          <p:nvPr/>
        </p:nvSpPr>
        <p:spPr>
          <a:xfrm>
            <a:off x="4793745" y="1134402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3CF92F6-3B79-4D82-9717-90E47469728E}"/>
              </a:ext>
            </a:extLst>
          </p:cNvPr>
          <p:cNvSpPr txBox="1"/>
          <p:nvPr/>
        </p:nvSpPr>
        <p:spPr>
          <a:xfrm>
            <a:off x="11250568" y="1063993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36AB4FC-F9B8-4324-8B26-7C9081544DEB}"/>
              </a:ext>
            </a:extLst>
          </p:cNvPr>
          <p:cNvSpPr txBox="1"/>
          <p:nvPr/>
        </p:nvSpPr>
        <p:spPr>
          <a:xfrm>
            <a:off x="17707388" y="1134399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3630D2-91EB-4284-99DA-64B646671DB3}"/>
              </a:ext>
            </a:extLst>
          </p:cNvPr>
          <p:cNvSpPr txBox="1"/>
          <p:nvPr/>
        </p:nvSpPr>
        <p:spPr>
          <a:xfrm>
            <a:off x="24204268" y="1063993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33813329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8731089-D942-4F30-A753-05F4C8678EB8}"/>
              </a:ext>
            </a:extLst>
          </p:cNvPr>
          <p:cNvSpPr txBox="1"/>
          <p:nvPr/>
        </p:nvSpPr>
        <p:spPr>
          <a:xfrm>
            <a:off x="11749108" y="523199"/>
            <a:ext cx="5827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health facility delivery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A6A8301-2E06-4B22-AF39-60C84F72F5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20486" y="1808443"/>
            <a:ext cx="6458400" cy="8724423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1AFA3FD6-AD3C-48BC-8207-3D158F33EAEC}"/>
              </a:ext>
            </a:extLst>
          </p:cNvPr>
          <p:cNvGrpSpPr/>
          <p:nvPr/>
        </p:nvGrpSpPr>
        <p:grpSpPr>
          <a:xfrm>
            <a:off x="2201582" y="2090088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290C2B5-5A1F-4E61-872C-32D50CF6829D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0AB69FA2-5205-459E-9DF1-BAEE307D0E1F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985D96E-3713-4F29-AAA2-ABEA52EDEE94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BCC90002-DA88-44D2-BA69-16E292F040C9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8DDAA52B-A7B2-4597-B8C7-4A41BD1CFC56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1AA3D60-8425-4B0A-AE8F-A03A38711BB6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8466F64-F906-40EB-975A-51B87E1267A2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CD0ABD5C-833E-40B1-94E6-D1721A96C803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393126BB-45C6-459C-B772-88117FE2EFF0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16D1054-C4AC-4733-93A1-BB3011B45146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D7C605B3-D17D-4078-BE0B-48A98A897415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073F8BB-7D69-432F-A2D6-E9FA37630041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379A997-0066-480C-BAEF-A960B5A31DEB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C066854B-75B4-4084-AD3C-481D174EFA49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6BCAE649-8DCC-47CB-A60E-343A7EAC8F8A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ABA2050-8CFB-4530-BE54-C9AC938EC0A8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690E97D0-4826-4878-A771-4096E34A9F30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3538CF3-57E2-429E-8EAA-6A7C93DE4B7C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19A8F43A-6F8E-43D0-9054-A94D8CEEDEB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296602" y="1808440"/>
            <a:ext cx="6525733" cy="877144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A3E6125-22F8-420B-9210-4CDAADB980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754254" y="1808440"/>
            <a:ext cx="6284659" cy="85725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E9CD276-3E86-41C7-9EBD-4C1B2D24984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45416" y="1768549"/>
            <a:ext cx="6284659" cy="85725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D4543C6A-75E6-4DB1-A3C9-69D8A78E95D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940441" y="3559886"/>
            <a:ext cx="1338602" cy="240948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9632ABCE-77CE-4A31-B0C3-516223667682}"/>
              </a:ext>
            </a:extLst>
          </p:cNvPr>
          <p:cNvSpPr txBox="1"/>
          <p:nvPr/>
        </p:nvSpPr>
        <p:spPr>
          <a:xfrm>
            <a:off x="5236943" y="1162112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62BC114-F175-4187-AF10-BCE70DC2CA8E}"/>
              </a:ext>
            </a:extLst>
          </p:cNvPr>
          <p:cNvSpPr txBox="1"/>
          <p:nvPr/>
        </p:nvSpPr>
        <p:spPr>
          <a:xfrm>
            <a:off x="11693766" y="1091703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3FB920-28E0-4386-9BFA-21E8FB555B94}"/>
              </a:ext>
            </a:extLst>
          </p:cNvPr>
          <p:cNvSpPr txBox="1"/>
          <p:nvPr/>
        </p:nvSpPr>
        <p:spPr>
          <a:xfrm>
            <a:off x="18150586" y="1162109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D51D03-AAB5-4D6C-8B1E-DD51E5296F68}"/>
              </a:ext>
            </a:extLst>
          </p:cNvPr>
          <p:cNvSpPr txBox="1"/>
          <p:nvPr/>
        </p:nvSpPr>
        <p:spPr>
          <a:xfrm>
            <a:off x="24647466" y="1091703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13744031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D1E5EE4-860B-462A-AC27-D40D9F3DBFE7}"/>
              </a:ext>
            </a:extLst>
          </p:cNvPr>
          <p:cNvSpPr txBox="1"/>
          <p:nvPr/>
        </p:nvSpPr>
        <p:spPr>
          <a:xfrm>
            <a:off x="11523545" y="349129"/>
            <a:ext cx="49648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HIV prevalence reduc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4343808-6263-4057-B708-53553573C6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44172" y="1804536"/>
            <a:ext cx="6458400" cy="8774999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26FA8250-BACE-4045-A7A4-B05D8FA15F8A}"/>
              </a:ext>
            </a:extLst>
          </p:cNvPr>
          <p:cNvGrpSpPr/>
          <p:nvPr/>
        </p:nvGrpSpPr>
        <p:grpSpPr>
          <a:xfrm>
            <a:off x="1620044" y="2086182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FF0F1EA-4C32-4E35-849C-15568496A0FD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33B0FA5A-D580-4152-A96B-23EC3F0885D6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6965F47-6366-4546-A5A1-61F2F449164C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D7424C1-9556-4B85-A589-46B481925C6D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66B39C4A-6095-44D7-A83B-EBDE03AF5C1B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8CB2D8B-3CC6-4090-8F3D-6562C5EF7D24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A657ADA-24D2-4F72-A7F5-DFCE3C4F339D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E9861BE8-C91C-41C3-891E-0DE44DE41EF2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85E4267-AF11-469F-B630-18B9161E93F6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7CECB75-F357-4257-BEFF-8CA5AECD5960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DC52ECA6-5A41-417F-A58D-23BFDFA2312C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F3B5B1E-2A94-42FC-AEBC-BFBDD18523E6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3DD17BAC-0E24-480D-8E6E-079304953755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C72E0AD3-BCC1-4BDD-9D2E-2C7DB0439196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6C63708-9B16-4180-AD14-BD03A87B487D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F348ED5-6EEA-4EA7-AEC2-6E81EDC305E3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F336593B-FF0D-45F0-8984-56D68ACA6268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E78747B-0C31-4F45-B453-E08EFCD831E5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D74EAB03-E9CA-4632-BC2B-BD9F447C01C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835800" y="1804533"/>
            <a:ext cx="6592142" cy="889323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338E8E5-155E-4A3B-A32B-A57FD793689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733187" y="1804533"/>
            <a:ext cx="6592142" cy="901269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E7D0F87-B471-47DC-B4CA-05267377086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291257" y="1804533"/>
            <a:ext cx="6355858" cy="85725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7E3BA81A-7B24-4727-A7FF-511949E1A10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25329" y="3414190"/>
            <a:ext cx="1108014" cy="1994425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4FE6FB4C-A0A3-4753-89BB-278F4947391B}"/>
              </a:ext>
            </a:extLst>
          </p:cNvPr>
          <p:cNvSpPr txBox="1"/>
          <p:nvPr/>
        </p:nvSpPr>
        <p:spPr>
          <a:xfrm>
            <a:off x="4921761" y="115820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71995A8-96C6-44C9-92B1-DE3A7E49023D}"/>
              </a:ext>
            </a:extLst>
          </p:cNvPr>
          <p:cNvSpPr txBox="1"/>
          <p:nvPr/>
        </p:nvSpPr>
        <p:spPr>
          <a:xfrm>
            <a:off x="113785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DB390B6-704F-4F00-9DFC-9ECA99DEF9ED}"/>
              </a:ext>
            </a:extLst>
          </p:cNvPr>
          <p:cNvSpPr txBox="1"/>
          <p:nvPr/>
        </p:nvSpPr>
        <p:spPr>
          <a:xfrm>
            <a:off x="17835404" y="1158202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29A59B6-94D5-4722-B711-6AB6355B9BBA}"/>
              </a:ext>
            </a:extLst>
          </p:cNvPr>
          <p:cNvSpPr txBox="1"/>
          <p:nvPr/>
        </p:nvSpPr>
        <p:spPr>
          <a:xfrm>
            <a:off x="243322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36393247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FC050A-3620-4460-94F2-4A59942E9246}"/>
              </a:ext>
            </a:extLst>
          </p:cNvPr>
          <p:cNvSpPr txBox="1"/>
          <p:nvPr/>
        </p:nvSpPr>
        <p:spPr>
          <a:xfrm>
            <a:off x="10550114" y="229960"/>
            <a:ext cx="53335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full immunis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3611D50-0C75-482B-9CEA-8FE60A6634D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36780" y="1837627"/>
            <a:ext cx="6458400" cy="8749638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CBDB16A4-3364-4BC2-8F31-1597952D1C73}"/>
              </a:ext>
            </a:extLst>
          </p:cNvPr>
          <p:cNvGrpSpPr/>
          <p:nvPr/>
        </p:nvGrpSpPr>
        <p:grpSpPr>
          <a:xfrm>
            <a:off x="2022380" y="1970939"/>
            <a:ext cx="1488880" cy="7736217"/>
            <a:chOff x="5720570" y="952909"/>
            <a:chExt cx="967168" cy="8455543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014AE9B4-E6B5-44A7-B2A6-60FD8ED82BA0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22" name="Left Brace 21">
                <a:extLst>
                  <a:ext uri="{FF2B5EF4-FFF2-40B4-BE49-F238E27FC236}">
                    <a16:creationId xmlns:a16="http://schemas.microsoft.com/office/drawing/2014/main" id="{3E61317F-9ABD-425D-835B-2AAD2B138D1D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931DA9D-3CE4-4D2E-974A-196991098972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21DCCD4-9D83-4E58-BE37-CCA35080400C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20" name="Left Brace 19">
                <a:extLst>
                  <a:ext uri="{FF2B5EF4-FFF2-40B4-BE49-F238E27FC236}">
                    <a16:creationId xmlns:a16="http://schemas.microsoft.com/office/drawing/2014/main" id="{59A6AB26-ACD5-4020-9632-E5160E41DFF3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17F5B1A-A0E5-4C68-88BA-FE873FD2798A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77B8D5F-44FD-4A27-BE88-F5FC84D29CB4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18" name="Left Brace 17">
                <a:extLst>
                  <a:ext uri="{FF2B5EF4-FFF2-40B4-BE49-F238E27FC236}">
                    <a16:creationId xmlns:a16="http://schemas.microsoft.com/office/drawing/2014/main" id="{146CD93B-4103-4F14-B63A-CD379B01472F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E9EAAE3-A405-4CA9-8EC3-19B535EDD2C3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28C96ECE-15DA-40C7-97A3-C80F73F17C5B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16" name="Left Brace 15">
                <a:extLst>
                  <a:ext uri="{FF2B5EF4-FFF2-40B4-BE49-F238E27FC236}">
                    <a16:creationId xmlns:a16="http://schemas.microsoft.com/office/drawing/2014/main" id="{8A2C52AA-824B-4CD2-9E95-AE527347AAD1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7867CF0-69BC-4E57-B24F-0A595C787628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AF12F708-9566-4845-A444-3820FAEF587F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14" name="Left Brace 13">
                <a:extLst>
                  <a:ext uri="{FF2B5EF4-FFF2-40B4-BE49-F238E27FC236}">
                    <a16:creationId xmlns:a16="http://schemas.microsoft.com/office/drawing/2014/main" id="{19BB2071-4DB5-430B-86BC-B90E60F01567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2A2ACA3-1224-4C8C-8E5F-E1E04FD20C8D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2A5CE9B-3AED-4056-B227-CF15DAF21998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12" name="Left Brace 11">
                <a:extLst>
                  <a:ext uri="{FF2B5EF4-FFF2-40B4-BE49-F238E27FC236}">
                    <a16:creationId xmlns:a16="http://schemas.microsoft.com/office/drawing/2014/main" id="{AA9E12CE-FB25-49F4-95DD-F4F1ADD3EA06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1749CE1-1489-4095-AD58-22CF7E12F994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38FE2367-F62D-4972-A0D8-3765DC212E8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030049" y="1837627"/>
            <a:ext cx="6458401" cy="85725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A1D9C72-8C9B-44D6-966D-D2EC61366A6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488450" y="1837627"/>
            <a:ext cx="6342017" cy="85725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4AAC01F-B193-4E12-A831-4FDD8333916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41604" y="1837627"/>
            <a:ext cx="6342018" cy="85725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C2A7C30-66F2-4C7F-8418-C43802CFCD6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872136" y="3573290"/>
            <a:ext cx="1338602" cy="240948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9E2C9C36-AA9E-4721-84F3-10D5D3A43746}"/>
              </a:ext>
            </a:extLst>
          </p:cNvPr>
          <p:cNvSpPr txBox="1"/>
          <p:nvPr/>
        </p:nvSpPr>
        <p:spPr>
          <a:xfrm>
            <a:off x="4921761" y="115820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C1D9D05-6C5A-4B66-BEA2-95D375E8275B}"/>
              </a:ext>
            </a:extLst>
          </p:cNvPr>
          <p:cNvSpPr txBox="1"/>
          <p:nvPr/>
        </p:nvSpPr>
        <p:spPr>
          <a:xfrm>
            <a:off x="113785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064A7AF-4A03-4719-A25F-C53EEB2D9DAA}"/>
              </a:ext>
            </a:extLst>
          </p:cNvPr>
          <p:cNvSpPr txBox="1"/>
          <p:nvPr/>
        </p:nvSpPr>
        <p:spPr>
          <a:xfrm>
            <a:off x="17835404" y="1158202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8EC88C8-91CE-48A1-A35E-7F1CAEBE6D0A}"/>
              </a:ext>
            </a:extLst>
          </p:cNvPr>
          <p:cNvSpPr txBox="1"/>
          <p:nvPr/>
        </p:nvSpPr>
        <p:spPr>
          <a:xfrm>
            <a:off x="243322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24491204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F3C2D55-2486-4D2F-94D6-DDC51FE5AB14}"/>
              </a:ext>
            </a:extLst>
          </p:cNvPr>
          <p:cNvSpPr txBox="1"/>
          <p:nvPr/>
        </p:nvSpPr>
        <p:spPr>
          <a:xfrm>
            <a:off x="12784437" y="680312"/>
            <a:ext cx="64716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206426"/>
            <a:r>
              <a:rPr lang="en-GB" sz="2000" b="1" kern="0" dirty="0">
                <a:solidFill>
                  <a:prstClr val="black"/>
                </a:solidFill>
              </a:rPr>
              <a:t>U5M changes after scale up of improved water for drinking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EC880A53-5250-4273-A591-9DAD8F02F2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726787" y="1853881"/>
            <a:ext cx="6525193" cy="87516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D572A25-424F-4B2C-949E-6A11487461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13081" y="1853881"/>
            <a:ext cx="6430598" cy="8751600"/>
          </a:xfrm>
          <a:prstGeom prst="rect">
            <a:avLst/>
          </a:prstGeom>
        </p:spPr>
      </p:pic>
      <p:grpSp>
        <p:nvGrpSpPr>
          <p:cNvPr id="28" name="Group 27">
            <a:extLst>
              <a:ext uri="{FF2B5EF4-FFF2-40B4-BE49-F238E27FC236}">
                <a16:creationId xmlns:a16="http://schemas.microsoft.com/office/drawing/2014/main" id="{625198CF-4E1C-4C3E-87F1-293C9848E504}"/>
              </a:ext>
            </a:extLst>
          </p:cNvPr>
          <p:cNvGrpSpPr/>
          <p:nvPr/>
        </p:nvGrpSpPr>
        <p:grpSpPr>
          <a:xfrm>
            <a:off x="1912652" y="2030588"/>
            <a:ext cx="1488880" cy="7736217"/>
            <a:chOff x="5720570" y="952909"/>
            <a:chExt cx="967168" cy="8455543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355EAEE8-C857-4013-9B22-12E9EEDC4738}"/>
                </a:ext>
              </a:extLst>
            </p:cNvPr>
            <p:cNvGrpSpPr/>
            <p:nvPr/>
          </p:nvGrpSpPr>
          <p:grpSpPr>
            <a:xfrm>
              <a:off x="5873547" y="8425541"/>
              <a:ext cx="630277" cy="982911"/>
              <a:chOff x="5873547" y="8425541"/>
              <a:chExt cx="630277" cy="982911"/>
            </a:xfrm>
          </p:grpSpPr>
          <p:sp>
            <p:nvSpPr>
              <p:cNvPr id="45" name="Left Brace 44">
                <a:extLst>
                  <a:ext uri="{FF2B5EF4-FFF2-40B4-BE49-F238E27FC236}">
                    <a16:creationId xmlns:a16="http://schemas.microsoft.com/office/drawing/2014/main" id="{85570720-2908-4C2A-BDF5-92F49574947A}"/>
                  </a:ext>
                </a:extLst>
              </p:cNvPr>
              <p:cNvSpPr/>
              <p:nvPr/>
            </p:nvSpPr>
            <p:spPr>
              <a:xfrm>
                <a:off x="6132681" y="8425541"/>
                <a:ext cx="371143" cy="982911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4D30A6D5-D5DA-422D-8F66-A40C2F59A4AB}"/>
                  </a:ext>
                </a:extLst>
              </p:cNvPr>
              <p:cNvSpPr txBox="1"/>
              <p:nvPr/>
            </p:nvSpPr>
            <p:spPr>
              <a:xfrm rot="16200000">
                <a:off x="5629804" y="8891110"/>
                <a:ext cx="707409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oast</a:t>
                </a: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6A68A037-0C05-49F4-89FD-83AB73ABEE28}"/>
                </a:ext>
              </a:extLst>
            </p:cNvPr>
            <p:cNvGrpSpPr/>
            <p:nvPr/>
          </p:nvGrpSpPr>
          <p:grpSpPr>
            <a:xfrm>
              <a:off x="5720570" y="7474494"/>
              <a:ext cx="919751" cy="882678"/>
              <a:chOff x="6341967" y="8639265"/>
              <a:chExt cx="1118908" cy="882678"/>
            </a:xfrm>
          </p:grpSpPr>
          <p:sp>
            <p:nvSpPr>
              <p:cNvPr id="43" name="Left Brace 42">
                <a:extLst>
                  <a:ext uri="{FF2B5EF4-FFF2-40B4-BE49-F238E27FC236}">
                    <a16:creationId xmlns:a16="http://schemas.microsoft.com/office/drawing/2014/main" id="{F9CFB3C7-79AD-44A3-9990-A43E4DEBEB99}"/>
                  </a:ext>
                </a:extLst>
              </p:cNvPr>
              <p:cNvSpPr/>
              <p:nvPr/>
            </p:nvSpPr>
            <p:spPr>
              <a:xfrm>
                <a:off x="6898989" y="8775971"/>
                <a:ext cx="561886" cy="656460"/>
              </a:xfrm>
              <a:prstGeom prst="leftBrace">
                <a:avLst>
                  <a:gd name="adj1" fmla="val 5931"/>
                  <a:gd name="adj2" fmla="val 50000"/>
                </a:avLst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51F04D6A-41AE-428F-B663-DF782FF3BBE1}"/>
                  </a:ext>
                </a:extLst>
              </p:cNvPr>
              <p:cNvSpPr txBox="1"/>
              <p:nvPr/>
            </p:nvSpPr>
            <p:spPr>
              <a:xfrm rot="16200000">
                <a:off x="6131688" y="8849544"/>
                <a:ext cx="882678" cy="462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North</a:t>
                </a:r>
              </a:p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76A64F7E-38D6-49C8-B2CD-28321F74FE94}"/>
                </a:ext>
              </a:extLst>
            </p:cNvPr>
            <p:cNvGrpSpPr/>
            <p:nvPr/>
          </p:nvGrpSpPr>
          <p:grpSpPr>
            <a:xfrm>
              <a:off x="5826416" y="6432803"/>
              <a:ext cx="861322" cy="1068411"/>
              <a:chOff x="5826416" y="8295550"/>
              <a:chExt cx="861322" cy="1068411"/>
            </a:xfrm>
          </p:grpSpPr>
          <p:sp>
            <p:nvSpPr>
              <p:cNvPr id="41" name="Left Brace 40">
                <a:extLst>
                  <a:ext uri="{FF2B5EF4-FFF2-40B4-BE49-F238E27FC236}">
                    <a16:creationId xmlns:a16="http://schemas.microsoft.com/office/drawing/2014/main" id="{16ACD833-508E-4DA9-8913-F2D7EE6DF83A}"/>
                  </a:ext>
                </a:extLst>
              </p:cNvPr>
              <p:cNvSpPr/>
              <p:nvPr/>
            </p:nvSpPr>
            <p:spPr>
              <a:xfrm>
                <a:off x="6158768" y="8295551"/>
                <a:ext cx="528970" cy="106841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8769500-A2CF-4114-AEEB-FE9DC597640B}"/>
                  </a:ext>
                </a:extLst>
              </p:cNvPr>
              <p:cNvSpPr txBox="1"/>
              <p:nvPr/>
            </p:nvSpPr>
            <p:spPr>
              <a:xfrm rot="16200000">
                <a:off x="5495491" y="8626475"/>
                <a:ext cx="881773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Eastern</a:t>
                </a:r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FE4AB785-EA33-4A34-8E7A-BDE58FEA8FF2}"/>
                </a:ext>
              </a:extLst>
            </p:cNvPr>
            <p:cNvGrpSpPr/>
            <p:nvPr/>
          </p:nvGrpSpPr>
          <p:grpSpPr>
            <a:xfrm>
              <a:off x="5827850" y="5542444"/>
              <a:ext cx="831026" cy="856351"/>
              <a:chOff x="5851582" y="8762390"/>
              <a:chExt cx="831026" cy="856351"/>
            </a:xfrm>
          </p:grpSpPr>
          <p:sp>
            <p:nvSpPr>
              <p:cNvPr id="39" name="Left Brace 38">
                <a:extLst>
                  <a:ext uri="{FF2B5EF4-FFF2-40B4-BE49-F238E27FC236}">
                    <a16:creationId xmlns:a16="http://schemas.microsoft.com/office/drawing/2014/main" id="{4D676C21-882B-4BDF-A3AB-5939DBEDEF7B}"/>
                  </a:ext>
                </a:extLst>
              </p:cNvPr>
              <p:cNvSpPr/>
              <p:nvPr/>
            </p:nvSpPr>
            <p:spPr>
              <a:xfrm>
                <a:off x="6083500" y="8762390"/>
                <a:ext cx="599108" cy="825700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FD2E60F7-7F5C-4D15-91EE-F72C2CB1A363}"/>
                  </a:ext>
                </a:extLst>
              </p:cNvPr>
              <p:cNvSpPr txBox="1"/>
              <p:nvPr/>
            </p:nvSpPr>
            <p:spPr>
              <a:xfrm rot="16200000">
                <a:off x="5533727" y="9080962"/>
                <a:ext cx="855634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Central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0A2D2D84-680B-4220-B7E8-7375879899E0}"/>
                </a:ext>
              </a:extLst>
            </p:cNvPr>
            <p:cNvGrpSpPr/>
            <p:nvPr/>
          </p:nvGrpSpPr>
          <p:grpSpPr>
            <a:xfrm>
              <a:off x="5761102" y="3170483"/>
              <a:ext cx="926636" cy="2307300"/>
              <a:chOff x="5846616" y="8754718"/>
              <a:chExt cx="926636" cy="727038"/>
            </a:xfrm>
          </p:grpSpPr>
          <p:sp>
            <p:nvSpPr>
              <p:cNvPr id="37" name="Left Brace 36">
                <a:extLst>
                  <a:ext uri="{FF2B5EF4-FFF2-40B4-BE49-F238E27FC236}">
                    <a16:creationId xmlns:a16="http://schemas.microsoft.com/office/drawing/2014/main" id="{CA9A0816-3DB5-4675-B07F-2C68EF281B62}"/>
                  </a:ext>
                </a:extLst>
              </p:cNvPr>
              <p:cNvSpPr/>
              <p:nvPr/>
            </p:nvSpPr>
            <p:spPr>
              <a:xfrm>
                <a:off x="6073946" y="8754718"/>
                <a:ext cx="699306" cy="727038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B14C69E-B433-4D3E-909F-61B7EA65A34D}"/>
                  </a:ext>
                </a:extLst>
              </p:cNvPr>
              <p:cNvSpPr txBox="1"/>
              <p:nvPr/>
            </p:nvSpPr>
            <p:spPr>
              <a:xfrm rot="16200000">
                <a:off x="5799644" y="9024044"/>
                <a:ext cx="313868" cy="2199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206426"/>
                <a:r>
                  <a:rPr lang="en-GB" sz="1200" dirty="0">
                    <a:solidFill>
                      <a:prstClr val="black"/>
                    </a:solidFill>
                    <a:latin typeface="Calibri" panose="020F0502020204030204"/>
                  </a:rPr>
                  <a:t>Rift </a:t>
                </a:r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valley</a:t>
                </a: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4DEF9904-9F77-44DB-A831-5894A06A57C9}"/>
                </a:ext>
              </a:extLst>
            </p:cNvPr>
            <p:cNvGrpSpPr/>
            <p:nvPr/>
          </p:nvGrpSpPr>
          <p:grpSpPr>
            <a:xfrm>
              <a:off x="5823809" y="952909"/>
              <a:ext cx="835068" cy="2107589"/>
              <a:chOff x="5847541" y="7642362"/>
              <a:chExt cx="835068" cy="2107589"/>
            </a:xfrm>
          </p:grpSpPr>
          <p:sp>
            <p:nvSpPr>
              <p:cNvPr id="35" name="Left Brace 34">
                <a:extLst>
                  <a:ext uri="{FF2B5EF4-FFF2-40B4-BE49-F238E27FC236}">
                    <a16:creationId xmlns:a16="http://schemas.microsoft.com/office/drawing/2014/main" id="{19551FB9-9A2E-4228-ACA1-DD03439DF5B7}"/>
                  </a:ext>
                </a:extLst>
              </p:cNvPr>
              <p:cNvSpPr/>
              <p:nvPr/>
            </p:nvSpPr>
            <p:spPr>
              <a:xfrm>
                <a:off x="6182500" y="7642362"/>
                <a:ext cx="500109" cy="2107589"/>
              </a:xfrm>
              <a:prstGeom prst="leftBrac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41288" tIns="20644" rIns="41288" bIns="2064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 defTabSz="206426"/>
                <a:endParaRPr lang="en-GB" sz="813">
                  <a:solidFill>
                    <a:prstClr val="black"/>
                  </a:solidFill>
                  <a:latin typeface="Calibri" panose="020F0502020204030204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23B85D3-DAC5-4B70-834C-2F38DA9A5475}"/>
                  </a:ext>
                </a:extLst>
              </p:cNvPr>
              <p:cNvSpPr txBox="1"/>
              <p:nvPr/>
            </p:nvSpPr>
            <p:spPr>
              <a:xfrm rot="16200000">
                <a:off x="5422391" y="8488425"/>
                <a:ext cx="1070224" cy="219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206426"/>
                <a:r>
                  <a:rPr lang="en-GB" sz="1600" dirty="0">
                    <a:solidFill>
                      <a:prstClr val="black"/>
                    </a:solidFill>
                    <a:latin typeface="Calibri" panose="020F0502020204030204"/>
                  </a:rPr>
                  <a:t>Western</a:t>
                </a:r>
              </a:p>
            </p:txBody>
          </p:sp>
        </p:grp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E0D301E4-9649-4440-B44A-776293CEF1E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251977" y="1853881"/>
            <a:ext cx="6289834" cy="85725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39EFDAA6-FDE9-4AAA-8C05-F7FB2719515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443682" y="1853881"/>
            <a:ext cx="6283105" cy="85725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00B8309C-4CC4-470A-97C3-B8868A7F81E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8783989" y="3500386"/>
            <a:ext cx="1338602" cy="2409484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0872B915-980E-4CC5-B7E2-2771BBA13DC8}"/>
              </a:ext>
            </a:extLst>
          </p:cNvPr>
          <p:cNvSpPr txBox="1"/>
          <p:nvPr/>
        </p:nvSpPr>
        <p:spPr>
          <a:xfrm>
            <a:off x="4921761" y="1158205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1: Best preforming county coverage 2014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034A177-B6D8-4049-B8AB-0CA21D751446}"/>
              </a:ext>
            </a:extLst>
          </p:cNvPr>
          <p:cNvSpPr txBox="1"/>
          <p:nvPr/>
        </p:nvSpPr>
        <p:spPr>
          <a:xfrm>
            <a:off x="113785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2: Fastest rate of  change between 2003-201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5370343-F0C4-45FC-8FE4-6ACDD1DDBD27}"/>
              </a:ext>
            </a:extLst>
          </p:cNvPr>
          <p:cNvSpPr txBox="1"/>
          <p:nvPr/>
        </p:nvSpPr>
        <p:spPr>
          <a:xfrm>
            <a:off x="17835404" y="1158202"/>
            <a:ext cx="37658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3: Projected National target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FAC9CDE-B17E-482E-9EC5-254D0D9F3561}"/>
              </a:ext>
            </a:extLst>
          </p:cNvPr>
          <p:cNvSpPr txBox="1"/>
          <p:nvPr/>
        </p:nvSpPr>
        <p:spPr>
          <a:xfrm>
            <a:off x="24332284" y="1087796"/>
            <a:ext cx="3401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cenario 4:Kenya health strategy plans targets</a:t>
            </a:r>
          </a:p>
        </p:txBody>
      </p:sp>
    </p:spTree>
    <p:extLst>
      <p:ext uri="{BB962C8B-B14F-4D97-AF65-F5344CB8AC3E}">
        <p14:creationId xmlns:p14="http://schemas.microsoft.com/office/powerpoint/2010/main" val="2126779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47</TotalTime>
  <Words>625</Words>
  <Application>Microsoft Office PowerPoint</Application>
  <PresentationFormat>Custom</PresentationFormat>
  <Paragraphs>12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el Joseph</dc:creator>
  <cp:lastModifiedBy>Noel Joseph</cp:lastModifiedBy>
  <cp:revision>57</cp:revision>
  <dcterms:created xsi:type="dcterms:W3CDTF">2021-07-08T19:06:28Z</dcterms:created>
  <dcterms:modified xsi:type="dcterms:W3CDTF">2022-06-06T08:59:56Z</dcterms:modified>
</cp:coreProperties>
</file>